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8" r:id="rId4"/>
  </p:sldIdLst>
  <p:sldSz cx="16200438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4">
          <p15:clr>
            <a:srgbClr val="A4A3A4"/>
          </p15:clr>
        </p15:guide>
        <p15:guide id="2" pos="510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EBFDC3D-DFC0-6D46-9C42-633FA7C7D54B}" v="9" dt="2022-02-11T21:49:06.51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755"/>
  </p:normalViewPr>
  <p:slideViewPr>
    <p:cSldViewPr snapToGrid="0" snapToObjects="1">
      <p:cViewPr>
        <p:scale>
          <a:sx n="125" d="100"/>
          <a:sy n="125" d="100"/>
        </p:scale>
        <p:origin x="-1518" y="-1284"/>
      </p:cViewPr>
      <p:guideLst>
        <p:guide orient="horz" pos="2834"/>
        <p:guide pos="51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25055" y="1472842"/>
            <a:ext cx="12150329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25055" y="4726842"/>
            <a:ext cx="12150329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0DD7-C770-B04D-AF13-65FAA7A8B2C9}" type="datetimeFigureOut">
              <a:rPr lang="en-US" smtClean="0"/>
              <a:pPr/>
              <a:t>2022-02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A2159-7946-5444-9BB2-3E1CA48F72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5490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0DD7-C770-B04D-AF13-65FAA7A8B2C9}" type="datetimeFigureOut">
              <a:rPr lang="en-US" smtClean="0"/>
              <a:pPr/>
              <a:t>2022-02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A2159-7946-5444-9BB2-3E1CA48F72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042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593439" y="479142"/>
            <a:ext cx="3493219" cy="7626692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3780" y="479142"/>
            <a:ext cx="10277153" cy="7626692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0DD7-C770-B04D-AF13-65FAA7A8B2C9}" type="datetimeFigureOut">
              <a:rPr lang="en-US" smtClean="0"/>
              <a:pPr/>
              <a:t>2022-02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A2159-7946-5444-9BB2-3E1CA48F72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050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0DD7-C770-B04D-AF13-65FAA7A8B2C9}" type="datetimeFigureOut">
              <a:rPr lang="en-US" smtClean="0"/>
              <a:pPr/>
              <a:t>2022-02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A2159-7946-5444-9BB2-3E1CA48F72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2923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5342" y="2243636"/>
            <a:ext cx="13972878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5342" y="6022609"/>
            <a:ext cx="13972878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0DD7-C770-B04D-AF13-65FAA7A8B2C9}" type="datetimeFigureOut">
              <a:rPr lang="en-US" smtClean="0"/>
              <a:pPr/>
              <a:t>2022-02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A2159-7946-5444-9BB2-3E1CA48F72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519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3780" y="2395710"/>
            <a:ext cx="6885186" cy="571012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01472" y="2395710"/>
            <a:ext cx="6885186" cy="571012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0DD7-C770-B04D-AF13-65FAA7A8B2C9}" type="datetimeFigureOut">
              <a:rPr lang="en-US" smtClean="0"/>
              <a:pPr/>
              <a:t>2022-02-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A2159-7946-5444-9BB2-3E1CA48F72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05472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479143"/>
            <a:ext cx="13972878" cy="1739495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891" y="2206137"/>
            <a:ext cx="6853544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5891" y="3287331"/>
            <a:ext cx="6853544" cy="483516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01472" y="2206137"/>
            <a:ext cx="6887296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01472" y="3287331"/>
            <a:ext cx="6887296" cy="483516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0DD7-C770-B04D-AF13-65FAA7A8B2C9}" type="datetimeFigureOut">
              <a:rPr lang="en-US" smtClean="0"/>
              <a:pPr/>
              <a:t>2022-02-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A2159-7946-5444-9BB2-3E1CA48F72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35669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0DD7-C770-B04D-AF13-65FAA7A8B2C9}" type="datetimeFigureOut">
              <a:rPr lang="en-US" smtClean="0"/>
              <a:pPr/>
              <a:t>2022-02-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A2159-7946-5444-9BB2-3E1CA48F72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364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0DD7-C770-B04D-AF13-65FAA7A8B2C9}" type="datetimeFigureOut">
              <a:rPr lang="en-US" smtClean="0"/>
              <a:pPr/>
              <a:t>2022-02-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A2159-7946-5444-9BB2-3E1CA48F72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112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1" y="599969"/>
            <a:ext cx="5225062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887296" y="1295767"/>
            <a:ext cx="8201472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1" y="2699862"/>
            <a:ext cx="5225062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0DD7-C770-B04D-AF13-65FAA7A8B2C9}" type="datetimeFigureOut">
              <a:rPr lang="en-US" smtClean="0"/>
              <a:pPr/>
              <a:t>2022-02-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A2159-7946-5444-9BB2-3E1CA48F72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316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1" y="599969"/>
            <a:ext cx="5225062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887296" y="1295767"/>
            <a:ext cx="8201472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1" y="2699862"/>
            <a:ext cx="5225062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0DD7-C770-B04D-AF13-65FAA7A8B2C9}" type="datetimeFigureOut">
              <a:rPr lang="en-US" smtClean="0"/>
              <a:pPr/>
              <a:t>2022-02-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A2159-7946-5444-9BB2-3E1CA48F72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3241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3780" y="479143"/>
            <a:ext cx="13972878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3780" y="2395710"/>
            <a:ext cx="13972878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3780" y="8341239"/>
            <a:ext cx="364509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060DD7-C770-B04D-AF13-65FAA7A8B2C9}" type="datetimeFigureOut">
              <a:rPr lang="en-US" smtClean="0"/>
              <a:pPr/>
              <a:t>2022-02-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66395" y="8341239"/>
            <a:ext cx="5467648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41559" y="8341239"/>
            <a:ext cx="364509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DA2159-7946-5444-9BB2-3E1CA48F72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369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8">
            <a:extLst>
              <a:ext uri="{FF2B5EF4-FFF2-40B4-BE49-F238E27FC236}">
                <a16:creationId xmlns:a16="http://schemas.microsoft.com/office/drawing/2014/main" id="{B949FD55-4B81-1A46-AFB4-68613962BF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5226" y="1780678"/>
            <a:ext cx="7233817" cy="12311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8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Decrease in RNase HII and accumulation of </a:t>
            </a:r>
            <a:r>
              <a:rPr lang="en-US" altLang="zh-CN" sz="1800" b="1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lncRNAs</a:t>
            </a:r>
            <a:r>
              <a:rPr lang="en-US" altLang="zh-CN" sz="18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/DNA hybrids: a causal implication in psoriasis?</a:t>
            </a:r>
            <a:endParaRPr lang="en-US" altLang="zh-CN" sz="1000" dirty="0"/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000" b="1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Ecmel</a:t>
            </a:r>
            <a:r>
              <a:rPr lang="en-US" altLang="zh-CN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 Mehmetbeyoglu</a:t>
            </a:r>
            <a:r>
              <a:rPr lang="en-US" altLang="zh-CN" sz="10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1,2*</a:t>
            </a:r>
            <a:r>
              <a:rPr lang="en-US" altLang="zh-CN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, Leila Kianmehr</a:t>
            </a:r>
            <a:r>
              <a:rPr lang="en-US" altLang="zh-CN" sz="10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5*</a:t>
            </a:r>
            <a:r>
              <a:rPr lang="en-US" altLang="zh-CN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,</a:t>
            </a:r>
            <a:r>
              <a:rPr lang="en-US" altLang="zh-CN" sz="1000" b="1" dirty="0">
                <a:solidFill>
                  <a:srgbClr val="212121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 </a:t>
            </a:r>
            <a:r>
              <a:rPr lang="en-US" altLang="zh-CN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Murat Borlu</a:t>
            </a:r>
            <a:r>
              <a:rPr lang="en-US" altLang="zh-CN" sz="10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3*</a:t>
            </a:r>
            <a:r>
              <a:rPr lang="en-US" altLang="zh-CN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, </a:t>
            </a:r>
            <a:r>
              <a:rPr lang="en-US" altLang="zh-CN" sz="1000" b="1" dirty="0">
                <a:solidFill>
                  <a:srgbClr val="212121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Zeynep Yilmaz</a:t>
            </a:r>
            <a:r>
              <a:rPr lang="en-US" altLang="zh-CN" sz="10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1,2</a:t>
            </a:r>
            <a:r>
              <a:rPr lang="en-US" altLang="zh-CN" sz="1000" b="1" dirty="0">
                <a:solidFill>
                  <a:srgbClr val="212121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, </a:t>
            </a:r>
            <a:r>
              <a:rPr lang="en-US" altLang="zh-CN" sz="1000" b="1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Seyma</a:t>
            </a:r>
            <a:r>
              <a:rPr lang="en-US" altLang="zh-CN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Basar</a:t>
            </a:r>
            <a:r>
              <a:rPr lang="en-US" altLang="zh-CN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 Kılıc</a:t>
            </a:r>
            <a:r>
              <a:rPr lang="en-US" altLang="zh-CN" sz="10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4</a:t>
            </a:r>
            <a:r>
              <a:rPr lang="en-US" altLang="zh-CN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,</a:t>
            </a:r>
            <a:r>
              <a:rPr lang="en-US" altLang="zh-CN" sz="10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 </a:t>
            </a:r>
            <a:r>
              <a:rPr lang="en-US" altLang="zh-CN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Hassan Rajabi-Maham</a:t>
            </a:r>
            <a:r>
              <a:rPr lang="en-US" altLang="zh-CN" sz="10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5</a:t>
            </a:r>
            <a:r>
              <a:rPr lang="en-US" altLang="zh-CN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, Serpil Taheri</a:t>
            </a:r>
            <a:r>
              <a:rPr lang="en-US" altLang="zh-CN" sz="10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1,2**</a:t>
            </a:r>
            <a:r>
              <a:rPr lang="en-US" altLang="zh-CN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 and </a:t>
            </a:r>
            <a:r>
              <a:rPr lang="en-US" altLang="zh-CN" sz="1000" b="1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Minoo</a:t>
            </a:r>
            <a:r>
              <a:rPr lang="en-US" altLang="zh-CN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 Rassoulzadegan</a:t>
            </a:r>
            <a:r>
              <a:rPr lang="en-US" altLang="zh-CN" sz="1000" b="1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1,6**</a:t>
            </a:r>
            <a:r>
              <a:rPr lang="en-US" altLang="zh-CN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Calibri Light" panose="020F0302020204030204" pitchFamily="34" charset="0"/>
              </a:rPr>
              <a:t> </a:t>
            </a:r>
            <a:endParaRPr lang="en-US" altLang="zh-CN" sz="1000" dirty="0"/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zh-CN" sz="1800" dirty="0">
              <a:latin typeface="Arial" panose="020B0604020202020204" pitchFamily="34" charset="0"/>
            </a:endParaRPr>
          </a:p>
        </p:txBody>
      </p:sp>
      <p:sp>
        <p:nvSpPr>
          <p:cNvPr id="13" name="Rectangle 9">
            <a:extLst>
              <a:ext uri="{FF2B5EF4-FFF2-40B4-BE49-F238E27FC236}">
                <a16:creationId xmlns:a16="http://schemas.microsoft.com/office/drawing/2014/main" id="{99E56071-C877-C64F-AAB3-F035863021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99007" y="3687567"/>
            <a:ext cx="8645393" cy="11079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32385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en-GB" altLang="en-US" sz="8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altLang="en-US" sz="8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Betul</a:t>
            </a:r>
            <a:r>
              <a:rPr lang="en-US" alt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 </a:t>
            </a:r>
            <a:r>
              <a:rPr lang="en-US" altLang="en-US" sz="8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Ziya</a:t>
            </a:r>
            <a:r>
              <a:rPr lang="en-US" alt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 </a:t>
            </a:r>
            <a:r>
              <a:rPr lang="en-US" altLang="en-US" sz="8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Eren</a:t>
            </a:r>
            <a:r>
              <a:rPr lang="en-US" alt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 Genome and Stem Cell Center, </a:t>
            </a:r>
            <a:r>
              <a:rPr lang="en-US" altLang="en-US" sz="8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Erciyes</a:t>
            </a:r>
            <a:r>
              <a:rPr lang="en-US" alt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 University, Kayseri, Turkey.</a:t>
            </a:r>
            <a:endParaRPr lang="en-US" altLang="en-US" sz="1000" dirty="0"/>
          </a:p>
          <a:p>
            <a:pPr defTabSz="914400"/>
            <a:r>
              <a:rPr lang="en-GB" altLang="en-US" sz="8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alt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alt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Department of Medical Biology, </a:t>
            </a:r>
            <a:r>
              <a:rPr lang="en-US" altLang="en-US" sz="8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Erciyes</a:t>
            </a:r>
            <a:r>
              <a:rPr lang="en-US" alt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 University Medical Faculty, Kayseri, Turkey.</a:t>
            </a:r>
            <a:r>
              <a:rPr lang="en-GB" alt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altLang="en-US" sz="1000" dirty="0"/>
          </a:p>
          <a:p>
            <a:pPr defTabSz="914400"/>
            <a:r>
              <a:rPr lang="en-GB" altLang="en-US" sz="8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 	</a:t>
            </a:r>
            <a:r>
              <a:rPr lang="en-US" altLang="en-US" sz="8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Erciyes</a:t>
            </a:r>
            <a:r>
              <a:rPr lang="en-US" alt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 University Medical School, Dermatology and Venereology Department, Kayseri, Turkey.</a:t>
            </a:r>
            <a:endParaRPr lang="en-US" altLang="en-US" sz="1000" dirty="0"/>
          </a:p>
          <a:p>
            <a:pPr defTabSz="914400"/>
            <a:r>
              <a:rPr lang="en-GB" altLang="en-US" sz="8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	</a:t>
            </a:r>
            <a:r>
              <a:rPr lang="en-US" altLang="en-US" sz="8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Aksaray</a:t>
            </a:r>
            <a:r>
              <a:rPr lang="en-US" alt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 </a:t>
            </a:r>
            <a:r>
              <a:rPr lang="en-US" altLang="en-US" sz="800" dirty="0">
                <a:solidFill>
                  <a:srgbClr val="212121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University Training and Research Hospital, </a:t>
            </a:r>
            <a:r>
              <a:rPr lang="en-US" alt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Dermatology and Venereology Department, </a:t>
            </a:r>
            <a:r>
              <a:rPr lang="en-US" altLang="en-US" sz="8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Aksaray</a:t>
            </a:r>
            <a:r>
              <a:rPr lang="en-US" alt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, Turkey.</a:t>
            </a:r>
            <a:endParaRPr lang="en-US" altLang="en-US" sz="1000" dirty="0"/>
          </a:p>
          <a:p>
            <a:pPr defTabSz="914400"/>
            <a:r>
              <a:rPr lang="en-GB" altLang="en-US" sz="8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	</a:t>
            </a:r>
            <a:r>
              <a:rPr lang="en-US" alt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Animal Sciences and Biotechnology Department, Faculty of Life Sciences and Biotechnology, Shahid </a:t>
            </a:r>
            <a:r>
              <a:rPr lang="en-US" altLang="en-US" sz="8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Beheshty</a:t>
            </a:r>
            <a:r>
              <a:rPr lang="en-US" alt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 University, Tehran, Iran.</a:t>
            </a:r>
            <a:endParaRPr lang="en-US" altLang="en-US" sz="1000" dirty="0"/>
          </a:p>
          <a:p>
            <a:pPr defTabSz="914400"/>
            <a:r>
              <a:rPr lang="fr-FR" altLang="en-US" sz="8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6	</a:t>
            </a:r>
            <a:r>
              <a:rPr lang="fr-FR" alt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Université de Nice, INSERM-CNRS, France.</a:t>
            </a:r>
            <a:endParaRPr lang="fr-FR" altLang="en-US" sz="1000" dirty="0"/>
          </a:p>
          <a:p>
            <a:pPr defTabSz="914400"/>
            <a:r>
              <a:rPr lang="fr-FR" altLang="zh-CN" sz="10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	</a:t>
            </a:r>
            <a:endParaRPr lang="fr-FR" altLang="zh-CN" sz="1000" dirty="0"/>
          </a:p>
          <a:p>
            <a:pPr indent="0" defTabSz="914400"/>
            <a:r>
              <a:rPr lang="en-US" altLang="zh-CN" sz="8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zh-CN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	Correspondence: </a:t>
            </a:r>
            <a:r>
              <a:rPr lang="en-US" altLang="zh-CN" sz="8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noo@</a:t>
            </a:r>
            <a:r>
              <a:rPr lang="en-US" altLang="zh-CN" sz="80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ice.fr</a:t>
            </a:r>
            <a:r>
              <a:rPr lang="en-US" altLang="zh-CN" sz="8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minooh@wanadoo.fr; serpiltaheri@hotmail.com</a:t>
            </a:r>
            <a:endParaRPr lang="en-US" altLang="zh-CN" sz="1800" dirty="0"/>
          </a:p>
        </p:txBody>
      </p:sp>
    </p:spTree>
    <p:extLst>
      <p:ext uri="{BB962C8B-B14F-4D97-AF65-F5344CB8AC3E}">
        <p14:creationId xmlns:p14="http://schemas.microsoft.com/office/powerpoint/2010/main" val="14571341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D175A32-8466-7840-8A58-D5D65EB153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7183" y="282098"/>
            <a:ext cx="7590691" cy="7292181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5C6D0FA6-095B-E946-AF91-4A59985EB88E}"/>
              </a:ext>
            </a:extLst>
          </p:cNvPr>
          <p:cNvSpPr/>
          <p:nvPr/>
        </p:nvSpPr>
        <p:spPr>
          <a:xfrm>
            <a:off x="8536148" y="7574279"/>
            <a:ext cx="6096000" cy="107721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GB" sz="1600" dirty="0"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1. TERRA levels in psoriasis and healthy control DNA-RNA hybrids. Relative normalized expression of chromosomes: 1q (A); 2q (B); 7p (C); 9p (D); 10q (E); 13q (F); 15q (G); 18p (H); </a:t>
            </a:r>
            <a:r>
              <a:rPr lang="en-GB" sz="1600" dirty="0" err="1"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X</a:t>
            </a:r>
            <a:r>
              <a:rPr lang="en-GB" sz="1600" baseline="-25000" dirty="0" err="1"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q</a:t>
            </a:r>
            <a:r>
              <a:rPr lang="en-GB" sz="1600" dirty="0" err="1"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Y</a:t>
            </a:r>
            <a:r>
              <a:rPr lang="en-GB" sz="1600" baseline="-25000" dirty="0" err="1"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q</a:t>
            </a:r>
            <a:r>
              <a:rPr lang="en-GB" sz="1600" dirty="0"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 (I); </a:t>
            </a:r>
            <a:r>
              <a:rPr lang="en-GB" sz="1600" dirty="0" err="1"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X</a:t>
            </a:r>
            <a:r>
              <a:rPr lang="en-GB" sz="1600" baseline="-25000" dirty="0" err="1"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GB" sz="1600" dirty="0" err="1"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Y</a:t>
            </a:r>
            <a:r>
              <a:rPr lang="en-GB" sz="1600" baseline="-25000" dirty="0" err="1"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GB" sz="1600" dirty="0"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 (J); 17p (K); </a:t>
            </a:r>
            <a:endParaRPr lang="en-US" sz="1600" dirty="0"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457D8D91-8B44-384B-BEAA-DD882AF9ACA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3350536"/>
              </p:ext>
            </p:extLst>
          </p:nvPr>
        </p:nvGraphicFramePr>
        <p:xfrm>
          <a:off x="9339263" y="2622945"/>
          <a:ext cx="5946458" cy="2438400"/>
        </p:xfrm>
        <a:graphic>
          <a:graphicData uri="http://schemas.openxmlformats.org/drawingml/2006/table">
            <a:tbl>
              <a:tblPr>
                <a:tableStyleId>{2A488322-F2BA-4B5B-9748-0D474271808F}</a:tableStyleId>
              </a:tblPr>
              <a:tblGrid>
                <a:gridCol w="1152209">
                  <a:extLst>
                    <a:ext uri="{9D8B030D-6E8A-4147-A177-3AD203B41FA5}">
                      <a16:colId xmlns:a16="http://schemas.microsoft.com/office/drawing/2014/main" val="1653160116"/>
                    </a:ext>
                  </a:extLst>
                </a:gridCol>
                <a:gridCol w="1898648">
                  <a:extLst>
                    <a:ext uri="{9D8B030D-6E8A-4147-A177-3AD203B41FA5}">
                      <a16:colId xmlns:a16="http://schemas.microsoft.com/office/drawing/2014/main" val="2824158021"/>
                    </a:ext>
                  </a:extLst>
                </a:gridCol>
                <a:gridCol w="1743392">
                  <a:extLst>
                    <a:ext uri="{9D8B030D-6E8A-4147-A177-3AD203B41FA5}">
                      <a16:colId xmlns:a16="http://schemas.microsoft.com/office/drawing/2014/main" val="3642116640"/>
                    </a:ext>
                  </a:extLst>
                </a:gridCol>
                <a:gridCol w="1152209">
                  <a:extLst>
                    <a:ext uri="{9D8B030D-6E8A-4147-A177-3AD203B41FA5}">
                      <a16:colId xmlns:a16="http://schemas.microsoft.com/office/drawing/2014/main" val="2044927388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PSO </a:t>
                      </a:r>
                      <a:r>
                        <a:rPr lang="en-GB" sz="1200" b="1" u="none" strike="noStrike" dirty="0" err="1">
                          <a:effectLst/>
                        </a:rPr>
                        <a:t>lesional</a:t>
                      </a:r>
                      <a:r>
                        <a:rPr lang="en-GB" sz="1200" b="1" u="none" strike="noStrike" dirty="0">
                          <a:effectLst/>
                        </a:rPr>
                        <a:t> RNA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PSO non-</a:t>
                      </a:r>
                      <a:r>
                        <a:rPr lang="en-GB" sz="1200" b="1" u="none" strike="noStrike" dirty="0" err="1">
                          <a:effectLst/>
                        </a:rPr>
                        <a:t>lesional</a:t>
                      </a:r>
                      <a:r>
                        <a:rPr lang="en-GB" sz="1200" b="1" u="none" strike="noStrike" dirty="0">
                          <a:effectLst/>
                        </a:rPr>
                        <a:t> RNA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Control RNA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056671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1q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4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2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0.03 (0.01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45250824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2q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2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1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2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0215828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</a:rPr>
                        <a:t>13q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1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1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3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6478763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15q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3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2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3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8288153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9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6 (0.03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3 (0.02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2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5013255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7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2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1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4 (0.02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6275352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 err="1">
                          <a:effectLst/>
                        </a:rPr>
                        <a:t>XpY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2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1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4 (0.02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5924538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17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2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2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4 (0.02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942443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10q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0.01 (0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1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1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1548965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18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2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1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3 (0.01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7383641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 err="1">
                          <a:effectLst/>
                        </a:rPr>
                        <a:t>XqYq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02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01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0.05 (0.03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17724396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5F6B6AB9-A31D-394E-90AF-66AC48C40BEB}"/>
              </a:ext>
            </a:extLst>
          </p:cNvPr>
          <p:cNvSpPr txBox="1"/>
          <p:nvPr/>
        </p:nvSpPr>
        <p:spPr>
          <a:xfrm>
            <a:off x="9806375" y="5245306"/>
            <a:ext cx="1273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an(SEM)</a:t>
            </a:r>
          </a:p>
        </p:txBody>
      </p:sp>
    </p:spTree>
    <p:extLst>
      <p:ext uri="{BB962C8B-B14F-4D97-AF65-F5344CB8AC3E}">
        <p14:creationId xmlns:p14="http://schemas.microsoft.com/office/powerpoint/2010/main" val="9349895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7B1848F-1893-DB42-A9DD-CA01B5792112}"/>
              </a:ext>
            </a:extLst>
          </p:cNvPr>
          <p:cNvSpPr txBox="1"/>
          <p:nvPr/>
        </p:nvSpPr>
        <p:spPr>
          <a:xfrm>
            <a:off x="-1406454" y="7243973"/>
            <a:ext cx="13507014" cy="14080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2. </a:t>
            </a:r>
            <a:r>
              <a:rPr lang="en-US" sz="1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ERRA transcript levels in psoriasis and healthy control in terms of total free RNAs. </a:t>
            </a:r>
            <a:r>
              <a:rPr lang="en-US" sz="1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Level of TERRA transcripts were determined by RT-qPCR analysis: relative normalized expression of TERRA in PSO </a:t>
            </a:r>
            <a:r>
              <a:rPr lang="en-US" sz="18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lesional</a:t>
            </a:r>
            <a:r>
              <a:rPr lang="en-US" sz="1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, non-</a:t>
            </a:r>
            <a:r>
              <a:rPr lang="en-US" sz="18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lesional</a:t>
            </a:r>
            <a:r>
              <a:rPr lang="en-US" sz="1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 and healthy control in terms of RNA (total free-RNA fraction) of chromosomes: 1q (A), 2q (B), 13q (C), 15q (D), 9p (E), 7p (F), </a:t>
            </a:r>
            <a:r>
              <a:rPr lang="en-US" sz="18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XpYp</a:t>
            </a:r>
            <a:r>
              <a:rPr lang="en-US" sz="1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 (G), 17p (H), 10q (I), 18p (J) and </a:t>
            </a:r>
            <a:r>
              <a:rPr lang="en-US" sz="18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XqYq</a:t>
            </a:r>
            <a:r>
              <a:rPr lang="en-US" sz="1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alibri Light" panose="020F0302020204030204" pitchFamily="34" charset="0"/>
              </a:rPr>
              <a:t> (K). No difference in TERRA level were found in psoriasis samples (n=20) and control (n=15).</a:t>
            </a:r>
            <a:endParaRPr lang="en-GB" sz="16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78EA847C-0945-C44E-BABA-349F45C33D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649" y="162207"/>
            <a:ext cx="9986363" cy="6858000"/>
          </a:xfrm>
          <a:prstGeom prst="rect">
            <a:avLst/>
          </a:prstGeom>
        </p:spPr>
      </p:pic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94C0F97-E75F-944D-8349-11815B4834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64502878"/>
              </p:ext>
            </p:extLst>
          </p:nvPr>
        </p:nvGraphicFramePr>
        <p:xfrm>
          <a:off x="10347960" y="3194526"/>
          <a:ext cx="5318760" cy="2438400"/>
        </p:xfrm>
        <a:graphic>
          <a:graphicData uri="http://schemas.openxmlformats.org/drawingml/2006/table">
            <a:tbl>
              <a:tblPr>
                <a:tableStyleId>{2A488322-F2BA-4B5B-9748-0D474271808F}</a:tableStyleId>
              </a:tblPr>
              <a:tblGrid>
                <a:gridCol w="1329690">
                  <a:extLst>
                    <a:ext uri="{9D8B030D-6E8A-4147-A177-3AD203B41FA5}">
                      <a16:colId xmlns:a16="http://schemas.microsoft.com/office/drawing/2014/main" val="4293875903"/>
                    </a:ext>
                  </a:extLst>
                </a:gridCol>
                <a:gridCol w="1329690">
                  <a:extLst>
                    <a:ext uri="{9D8B030D-6E8A-4147-A177-3AD203B41FA5}">
                      <a16:colId xmlns:a16="http://schemas.microsoft.com/office/drawing/2014/main" val="537610481"/>
                    </a:ext>
                  </a:extLst>
                </a:gridCol>
                <a:gridCol w="1777702">
                  <a:extLst>
                    <a:ext uri="{9D8B030D-6E8A-4147-A177-3AD203B41FA5}">
                      <a16:colId xmlns:a16="http://schemas.microsoft.com/office/drawing/2014/main" val="231180391"/>
                    </a:ext>
                  </a:extLst>
                </a:gridCol>
                <a:gridCol w="881678">
                  <a:extLst>
                    <a:ext uri="{9D8B030D-6E8A-4147-A177-3AD203B41FA5}">
                      <a16:colId xmlns:a16="http://schemas.microsoft.com/office/drawing/2014/main" val="1377399926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PSO </a:t>
                      </a:r>
                      <a:r>
                        <a:rPr lang="en-GB" sz="1200" b="1" u="none" strike="noStrike" dirty="0" err="1">
                          <a:effectLst/>
                        </a:rPr>
                        <a:t>lesional</a:t>
                      </a:r>
                      <a:r>
                        <a:rPr lang="en-GB" sz="1200" b="1" u="none" strike="noStrike" dirty="0">
                          <a:effectLst/>
                        </a:rPr>
                        <a:t> RNA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PSO non-</a:t>
                      </a:r>
                      <a:r>
                        <a:rPr lang="en-GB" sz="1200" b="1" u="none" strike="noStrike" dirty="0" err="1">
                          <a:effectLst/>
                        </a:rPr>
                        <a:t>lesional</a:t>
                      </a:r>
                      <a:r>
                        <a:rPr lang="en-GB" sz="1200" b="1" u="none" strike="noStrike" dirty="0">
                          <a:effectLst/>
                        </a:rPr>
                        <a:t> RNA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Control RNA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631570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1q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1.52 (0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0.61 (0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34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6340975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9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.72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.48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36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7500445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10q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.31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97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36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624960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2q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.2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.24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34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6433994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7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.75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.29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34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1175545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18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.26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.04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31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978327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13q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.85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.64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16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5247722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 err="1">
                          <a:effectLst/>
                        </a:rPr>
                        <a:t>XpY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.13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.34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35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6113250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 err="1">
                          <a:effectLst/>
                        </a:rPr>
                        <a:t>XqYq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.4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7.04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51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4806787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15q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.18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.77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0.34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0669940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17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3.7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.1 (0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0.3 (0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77182952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681D54B0-D6F8-5C47-A2E1-E26CC433B8B2}"/>
              </a:ext>
            </a:extLst>
          </p:cNvPr>
          <p:cNvSpPr txBox="1"/>
          <p:nvPr/>
        </p:nvSpPr>
        <p:spPr>
          <a:xfrm>
            <a:off x="10827455" y="5672026"/>
            <a:ext cx="1273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an(SEM)</a:t>
            </a:r>
          </a:p>
        </p:txBody>
      </p:sp>
    </p:spTree>
    <p:extLst>
      <p:ext uri="{BB962C8B-B14F-4D97-AF65-F5344CB8AC3E}">
        <p14:creationId xmlns:p14="http://schemas.microsoft.com/office/powerpoint/2010/main" val="26535558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0</TotalTime>
  <Words>662</Words>
  <Application>Microsoft Office PowerPoint</Application>
  <PresentationFormat>Custom</PresentationFormat>
  <Paragraphs>10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Times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cmel Mehmetbeyoglu</dc:creator>
  <cp:lastModifiedBy>MDPI-67</cp:lastModifiedBy>
  <cp:revision>5</cp:revision>
  <dcterms:created xsi:type="dcterms:W3CDTF">2022-02-11T19:23:47Z</dcterms:created>
  <dcterms:modified xsi:type="dcterms:W3CDTF">2022-02-25T12:18:16Z</dcterms:modified>
</cp:coreProperties>
</file>